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8" r:id="rId2"/>
    <p:sldId id="273" r:id="rId3"/>
    <p:sldId id="261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75" d="100"/>
          <a:sy n="75" d="100"/>
        </p:scale>
        <p:origin x="902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vee\Desktop\MANUSCRIPT_1\figure_1_A_B_C\4_Tables%20for%20FIGURE_1_A_B_C_final_total%20apple%20included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8065725422435764E-2"/>
          <c:y val="8.0849646978841005E-2"/>
          <c:w val="0.54293842937415471"/>
          <c:h val="0.83098067287043664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ITS2'!$A$3</c:f>
              <c:strCache>
                <c:ptCount val="1"/>
                <c:pt idx="0">
                  <c:v>Ascomycot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ITS2'!$B$2:$D$2</c:f>
              <c:strCache>
                <c:ptCount val="3"/>
                <c:pt idx="0">
                  <c:v>Apple total</c:v>
                </c:pt>
                <c:pt idx="1">
                  <c:v>Orchard soil</c:v>
                </c:pt>
                <c:pt idx="2">
                  <c:v>Apple roots</c:v>
                </c:pt>
              </c:strCache>
            </c:strRef>
          </c:cat>
          <c:val>
            <c:numRef>
              <c:f>'ITS2'!$B$3:$D$3</c:f>
              <c:numCache>
                <c:formatCode>General</c:formatCode>
                <c:ptCount val="3"/>
                <c:pt idx="0">
                  <c:v>0.80365984502300003</c:v>
                </c:pt>
                <c:pt idx="1">
                  <c:v>0.67045324388399996</c:v>
                </c:pt>
                <c:pt idx="2">
                  <c:v>0.929466079431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3B8-4D94-B903-781A0E5167D8}"/>
            </c:ext>
          </c:extLst>
        </c:ser>
        <c:ser>
          <c:idx val="1"/>
          <c:order val="1"/>
          <c:tx>
            <c:strRef>
              <c:f>'ITS2'!$A$4</c:f>
              <c:strCache>
                <c:ptCount val="1"/>
                <c:pt idx="0">
                  <c:v>Basidiomycot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ITS2'!$B$2:$D$2</c:f>
              <c:strCache>
                <c:ptCount val="3"/>
                <c:pt idx="0">
                  <c:v>Apple total</c:v>
                </c:pt>
                <c:pt idx="1">
                  <c:v>Orchard soil</c:v>
                </c:pt>
                <c:pt idx="2">
                  <c:v>Apple roots</c:v>
                </c:pt>
              </c:strCache>
            </c:strRef>
          </c:cat>
          <c:val>
            <c:numRef>
              <c:f>'ITS2'!$B$4:$D$4</c:f>
              <c:numCache>
                <c:formatCode>General</c:formatCode>
                <c:ptCount val="3"/>
                <c:pt idx="0">
                  <c:v>0.13423008146199999</c:v>
                </c:pt>
                <c:pt idx="1">
                  <c:v>0.22065777632299999</c:v>
                </c:pt>
                <c:pt idx="2">
                  <c:v>5.26039252047999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3B8-4D94-B903-781A0E5167D8}"/>
            </c:ext>
          </c:extLst>
        </c:ser>
        <c:ser>
          <c:idx val="2"/>
          <c:order val="2"/>
          <c:tx>
            <c:strRef>
              <c:f>'ITS2'!$A$5</c:f>
              <c:strCache>
                <c:ptCount val="1"/>
                <c:pt idx="0">
                  <c:v>Mortierellomycota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ITS2'!$B$2:$D$2</c:f>
              <c:strCache>
                <c:ptCount val="3"/>
                <c:pt idx="0">
                  <c:v>Apple total</c:v>
                </c:pt>
                <c:pt idx="1">
                  <c:v>Orchard soil</c:v>
                </c:pt>
                <c:pt idx="2">
                  <c:v>Apple roots</c:v>
                </c:pt>
              </c:strCache>
            </c:strRef>
          </c:cat>
          <c:val>
            <c:numRef>
              <c:f>'ITS2'!$B$5:$D$5</c:f>
              <c:numCache>
                <c:formatCode>General</c:formatCode>
                <c:ptCount val="3"/>
                <c:pt idx="0">
                  <c:v>4.82952513411E-2</c:v>
                </c:pt>
                <c:pt idx="1">
                  <c:v>9.79505849628E-2</c:v>
                </c:pt>
                <c:pt idx="2">
                  <c:v>1.3985473651699999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3B8-4D94-B903-781A0E5167D8}"/>
            </c:ext>
          </c:extLst>
        </c:ser>
        <c:ser>
          <c:idx val="3"/>
          <c:order val="3"/>
          <c:tx>
            <c:strRef>
              <c:f>'ITS2'!$A$6</c:f>
              <c:strCache>
                <c:ptCount val="1"/>
                <c:pt idx="0">
                  <c:v>Glomeromycota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'ITS2'!$B$2:$D$2</c:f>
              <c:strCache>
                <c:ptCount val="3"/>
                <c:pt idx="0">
                  <c:v>Apple total</c:v>
                </c:pt>
                <c:pt idx="1">
                  <c:v>Orchard soil</c:v>
                </c:pt>
                <c:pt idx="2">
                  <c:v>Apple roots</c:v>
                </c:pt>
              </c:strCache>
            </c:strRef>
          </c:cat>
          <c:val>
            <c:numRef>
              <c:f>'ITS2'!$B$6:$D$6</c:f>
              <c:numCache>
                <c:formatCode>General</c:formatCode>
                <c:ptCount val="3"/>
                <c:pt idx="0">
                  <c:v>1.1126564673199999E-2</c:v>
                </c:pt>
                <c:pt idx="1">
                  <c:v>5.5714636341299998E-3</c:v>
                </c:pt>
                <c:pt idx="2">
                  <c:v>1.63730489877999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3B8-4D94-B903-781A0E5167D8}"/>
            </c:ext>
          </c:extLst>
        </c:ser>
        <c:ser>
          <c:idx val="4"/>
          <c:order val="4"/>
          <c:tx>
            <c:strRef>
              <c:f>'ITS2'!$A$7</c:f>
              <c:strCache>
                <c:ptCount val="1"/>
                <c:pt idx="0">
                  <c:v>Chytridiomycota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'ITS2'!$B$2:$D$2</c:f>
              <c:strCache>
                <c:ptCount val="3"/>
                <c:pt idx="0">
                  <c:v>Apple total</c:v>
                </c:pt>
                <c:pt idx="1">
                  <c:v>Orchard soil</c:v>
                </c:pt>
                <c:pt idx="2">
                  <c:v>Apple roots</c:v>
                </c:pt>
              </c:strCache>
            </c:strRef>
          </c:cat>
          <c:val>
            <c:numRef>
              <c:f>'ITS2'!$B$7:$D$7</c:f>
              <c:numCache>
                <c:formatCode>General</c:formatCode>
                <c:ptCount val="3"/>
                <c:pt idx="0">
                  <c:v>1.22392211405E-3</c:v>
                </c:pt>
                <c:pt idx="1">
                  <c:v>2.4748425100199999E-3</c:v>
                </c:pt>
                <c:pt idx="2" formatCode="0.00E+00">
                  <c:v>4.2497295626599999E-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3B8-4D94-B903-781A0E5167D8}"/>
            </c:ext>
          </c:extLst>
        </c:ser>
        <c:ser>
          <c:idx val="5"/>
          <c:order val="5"/>
          <c:tx>
            <c:strRef>
              <c:f>'ITS2'!$A$8</c:f>
              <c:strCache>
                <c:ptCount val="1"/>
                <c:pt idx="0">
                  <c:v>Kickxellomycota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'ITS2'!$B$2:$D$2</c:f>
              <c:strCache>
                <c:ptCount val="3"/>
                <c:pt idx="0">
                  <c:v>Apple total</c:v>
                </c:pt>
                <c:pt idx="1">
                  <c:v>Orchard soil</c:v>
                </c:pt>
                <c:pt idx="2">
                  <c:v>Apple roots</c:v>
                </c:pt>
              </c:strCache>
            </c:strRef>
          </c:cat>
          <c:val>
            <c:numRef>
              <c:f>'ITS2'!$B$8:$D$8</c:f>
              <c:numCache>
                <c:formatCode>General</c:formatCode>
                <c:ptCount val="3"/>
                <c:pt idx="0">
                  <c:v>4.6691833896300001E-4</c:v>
                </c:pt>
                <c:pt idx="1">
                  <c:v>9.4493986746299998E-4</c:v>
                </c:pt>
                <c:pt idx="2" formatCode="0.00E+00">
                  <c:v>1.5453562046099998E-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63B8-4D94-B903-781A0E5167D8}"/>
            </c:ext>
          </c:extLst>
        </c:ser>
        <c:ser>
          <c:idx val="6"/>
          <c:order val="6"/>
          <c:tx>
            <c:strRef>
              <c:f>'ITS2'!$A$9</c:f>
              <c:strCache>
                <c:ptCount val="1"/>
                <c:pt idx="0">
                  <c:v>Mucoromycota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ITS2'!$B$2:$D$2</c:f>
              <c:strCache>
                <c:ptCount val="3"/>
                <c:pt idx="0">
                  <c:v>Apple total</c:v>
                </c:pt>
                <c:pt idx="1">
                  <c:v>Orchard soil</c:v>
                </c:pt>
                <c:pt idx="2">
                  <c:v>Apple roots</c:v>
                </c:pt>
              </c:strCache>
            </c:strRef>
          </c:cat>
          <c:val>
            <c:numRef>
              <c:f>'ITS2'!$B$9:$D$9</c:f>
              <c:numCache>
                <c:formatCode>General</c:formatCode>
                <c:ptCount val="3"/>
                <c:pt idx="0">
                  <c:v>3.5366580568199998E-4</c:v>
                </c:pt>
                <c:pt idx="1">
                  <c:v>6.8313834574200004E-4</c:v>
                </c:pt>
                <c:pt idx="2" formatCode="0.00E+00">
                  <c:v>4.2497295626599999E-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63B8-4D94-B903-781A0E5167D8}"/>
            </c:ext>
          </c:extLst>
        </c:ser>
        <c:ser>
          <c:idx val="7"/>
          <c:order val="7"/>
          <c:tx>
            <c:strRef>
              <c:f>'ITS2'!$A$10</c:f>
              <c:strCache>
                <c:ptCount val="1"/>
                <c:pt idx="0">
                  <c:v>Cercozoa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ITS2'!$B$2:$D$2</c:f>
              <c:strCache>
                <c:ptCount val="3"/>
                <c:pt idx="0">
                  <c:v>Apple total</c:v>
                </c:pt>
                <c:pt idx="1">
                  <c:v>Orchard soil</c:v>
                </c:pt>
                <c:pt idx="2">
                  <c:v>Apple roots</c:v>
                </c:pt>
              </c:strCache>
            </c:strRef>
          </c:cat>
          <c:val>
            <c:numRef>
              <c:f>'ITS2'!$B$10:$D$10</c:f>
              <c:numCache>
                <c:formatCode>General</c:formatCode>
                <c:ptCount val="3"/>
                <c:pt idx="0">
                  <c:v>3.37770713292E-4</c:v>
                </c:pt>
                <c:pt idx="1">
                  <c:v>6.3814120919599999E-4</c:v>
                </c:pt>
                <c:pt idx="2" formatCode="0.00E+00">
                  <c:v>5.4087467161200002E-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63B8-4D94-B903-781A0E5167D8}"/>
            </c:ext>
          </c:extLst>
        </c:ser>
        <c:ser>
          <c:idx val="8"/>
          <c:order val="8"/>
          <c:tx>
            <c:strRef>
              <c:f>'ITS2'!$A$11</c:f>
              <c:strCache>
                <c:ptCount val="1"/>
                <c:pt idx="0">
                  <c:v>Basidiobolomycota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ITS2'!$B$2:$D$2</c:f>
              <c:strCache>
                <c:ptCount val="3"/>
                <c:pt idx="0">
                  <c:v>Apple total</c:v>
                </c:pt>
                <c:pt idx="1">
                  <c:v>Orchard soil</c:v>
                </c:pt>
                <c:pt idx="2">
                  <c:v>Apple roots</c:v>
                </c:pt>
              </c:strCache>
            </c:strRef>
          </c:cat>
          <c:val>
            <c:numRef>
              <c:f>'ITS2'!$B$11:$D$11</c:f>
              <c:numCache>
                <c:formatCode>General</c:formatCode>
                <c:ptCount val="3"/>
                <c:pt idx="0" formatCode="0.00E+00">
                  <c:v>9.5370554341299999E-5</c:v>
                </c:pt>
                <c:pt idx="1">
                  <c:v>1.96351141291E-4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63B8-4D94-B903-781A0E5167D8}"/>
            </c:ext>
          </c:extLst>
        </c:ser>
        <c:ser>
          <c:idx val="9"/>
          <c:order val="9"/>
          <c:tx>
            <c:strRef>
              <c:f>'ITS2'!$A$12</c:f>
              <c:strCache>
                <c:ptCount val="1"/>
                <c:pt idx="0">
                  <c:v>Calcarisporiellomycota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ITS2'!$B$2:$D$2</c:f>
              <c:strCache>
                <c:ptCount val="3"/>
                <c:pt idx="0">
                  <c:v>Apple total</c:v>
                </c:pt>
                <c:pt idx="1">
                  <c:v>Orchard soil</c:v>
                </c:pt>
                <c:pt idx="2">
                  <c:v>Apple roots</c:v>
                </c:pt>
              </c:strCache>
            </c:strRef>
          </c:cat>
          <c:val>
            <c:numRef>
              <c:f>'ITS2'!$B$12:$D$12</c:f>
              <c:numCache>
                <c:formatCode>General</c:formatCode>
                <c:ptCount val="3"/>
                <c:pt idx="0" formatCode="0.00E+00">
                  <c:v>6.35803695609E-5</c:v>
                </c:pt>
                <c:pt idx="1">
                  <c:v>1.30900760861E-4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63B8-4D94-B903-781A0E5167D8}"/>
            </c:ext>
          </c:extLst>
        </c:ser>
        <c:ser>
          <c:idx val="10"/>
          <c:order val="10"/>
          <c:tx>
            <c:strRef>
              <c:f>'ITS2'!$A$13</c:f>
              <c:strCache>
                <c:ptCount val="1"/>
                <c:pt idx="0">
                  <c:v>Aphelidiomycota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ITS2'!$B$2:$D$2</c:f>
              <c:strCache>
                <c:ptCount val="3"/>
                <c:pt idx="0">
                  <c:v>Apple total</c:v>
                </c:pt>
                <c:pt idx="1">
                  <c:v>Orchard soil</c:v>
                </c:pt>
                <c:pt idx="2">
                  <c:v>Apple roots</c:v>
                </c:pt>
              </c:strCache>
            </c:strRef>
          </c:cat>
          <c:val>
            <c:numRef>
              <c:f>'ITS2'!$B$13:$D$13</c:f>
              <c:numCache>
                <c:formatCode>General</c:formatCode>
                <c:ptCount val="3"/>
                <c:pt idx="0" formatCode="0.00E+00">
                  <c:v>5.3645936816999997E-5</c:v>
                </c:pt>
                <c:pt idx="1">
                  <c:v>1.1044751697599999E-4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63B8-4D94-B903-781A0E5167D8}"/>
            </c:ext>
          </c:extLst>
        </c:ser>
        <c:ser>
          <c:idx val="11"/>
          <c:order val="11"/>
          <c:tx>
            <c:strRef>
              <c:f>'ITS2'!$A$14</c:f>
              <c:strCache>
                <c:ptCount val="1"/>
                <c:pt idx="0">
                  <c:v>Rozellomycota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ITS2'!$B$2:$D$2</c:f>
              <c:strCache>
                <c:ptCount val="3"/>
                <c:pt idx="0">
                  <c:v>Apple total</c:v>
                </c:pt>
                <c:pt idx="1">
                  <c:v>Orchard soil</c:v>
                </c:pt>
                <c:pt idx="2">
                  <c:v>Apple roots</c:v>
                </c:pt>
              </c:strCache>
            </c:strRef>
          </c:cat>
          <c:val>
            <c:numRef>
              <c:f>'ITS2'!$B$14:$D$14</c:f>
              <c:numCache>
                <c:formatCode>0.00E+00</c:formatCode>
                <c:ptCount val="3"/>
                <c:pt idx="0">
                  <c:v>4.3711504073100001E-5</c:v>
                </c:pt>
                <c:pt idx="1">
                  <c:v>8.5903624314800006E-5</c:v>
                </c:pt>
                <c:pt idx="2">
                  <c:v>3.8633905115100004E-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63B8-4D94-B903-781A0E5167D8}"/>
            </c:ext>
          </c:extLst>
        </c:ser>
        <c:ser>
          <c:idx val="12"/>
          <c:order val="12"/>
          <c:tx>
            <c:strRef>
              <c:f>'ITS2'!$A$15</c:f>
              <c:strCache>
                <c:ptCount val="1"/>
                <c:pt idx="0">
                  <c:v>Olpidiomycota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ITS2'!$B$2:$D$2</c:f>
              <c:strCache>
                <c:ptCount val="3"/>
                <c:pt idx="0">
                  <c:v>Apple total</c:v>
                </c:pt>
                <c:pt idx="1">
                  <c:v>Orchard soil</c:v>
                </c:pt>
                <c:pt idx="2">
                  <c:v>Apple roots</c:v>
                </c:pt>
              </c:strCache>
            </c:strRef>
          </c:cat>
          <c:val>
            <c:numRef>
              <c:f>'ITS2'!$B$15:$D$15</c:f>
              <c:numCache>
                <c:formatCode>0.00E+00</c:formatCode>
                <c:ptCount val="3"/>
                <c:pt idx="0">
                  <c:v>2.3842638585299999E-5</c:v>
                </c:pt>
                <c:pt idx="1">
                  <c:v>4.9087785322800001E-5</c:v>
                </c:pt>
                <c:pt idx="2" formatCode="General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63B8-4D94-B903-781A0E5167D8}"/>
            </c:ext>
          </c:extLst>
        </c:ser>
        <c:ser>
          <c:idx val="13"/>
          <c:order val="13"/>
          <c:tx>
            <c:strRef>
              <c:f>'ITS2'!$A$16</c:f>
              <c:strCache>
                <c:ptCount val="1"/>
                <c:pt idx="0">
                  <c:v>Others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ITS2'!$B$2:$D$2</c:f>
              <c:strCache>
                <c:ptCount val="3"/>
                <c:pt idx="0">
                  <c:v>Apple total</c:v>
                </c:pt>
                <c:pt idx="1">
                  <c:v>Orchard soil</c:v>
                </c:pt>
                <c:pt idx="2">
                  <c:v>Apple roots</c:v>
                </c:pt>
              </c:strCache>
            </c:strRef>
          </c:cat>
          <c:val>
            <c:numRef>
              <c:f>'ITS2'!$B$16:$D$16</c:f>
              <c:numCache>
                <c:formatCode>0.00E+00</c:formatCode>
                <c:ptCount val="3"/>
                <c:pt idx="0">
                  <c:v>2.5829525335474557E-5</c:v>
                </c:pt>
                <c:pt idx="1">
                  <c:v>5.3178434883616177E-5</c:v>
                </c:pt>
                <c:pt idx="2">
                  <c:v>2.581268532253489E-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63B8-4D94-B903-781A0E5167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13653096"/>
        <c:axId val="309013448"/>
      </c:barChart>
      <c:catAx>
        <c:axId val="3136530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en-US"/>
          </a:p>
        </c:txPr>
        <c:crossAx val="309013448"/>
        <c:crosses val="autoZero"/>
        <c:auto val="1"/>
        <c:lblAlgn val="ctr"/>
        <c:lblOffset val="100"/>
        <c:noMultiLvlLbl val="0"/>
      </c:catAx>
      <c:valAx>
        <c:axId val="3090134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en-US"/>
          </a:p>
        </c:txPr>
        <c:crossAx val="3136530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7605384406945723"/>
          <c:y val="6.7764337913637743E-2"/>
          <c:w val="0.32394615593054282"/>
          <c:h val="0.93223566208636222"/>
        </c:manualLayout>
      </c:layout>
      <c:overlay val="0"/>
      <c:spPr>
        <a:noFill/>
        <a:ln>
          <a:solidFill>
            <a:schemeClr val="bg1"/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6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solidFill>
        <a:schemeClr val="bg1"/>
      </a:solidFill>
      <a:round/>
    </a:ln>
    <a:effectLst/>
  </c:spPr>
  <c:txPr>
    <a:bodyPr/>
    <a:lstStyle/>
    <a:p>
      <a:pPr>
        <a:defRPr sz="1050" baseline="0">
          <a:solidFill>
            <a:schemeClr val="tx1"/>
          </a:solidFill>
          <a:latin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5BAE82-F2D4-4093-BB93-7BFC2F6D6BD2}" type="datetimeFigureOut">
              <a:rPr lang="en-CA" smtClean="0"/>
              <a:t>2023-04-25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009A086-3F53-4246-87B3-737E7A95FC3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137511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S1. </a:t>
            </a:r>
            <a:r>
              <a:rPr lang="en-CA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lative abundances of major fungal phyla detected in orchard soil, apple roots and apple total.</a:t>
            </a:r>
            <a:endParaRPr lang="en-CA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014533-58CC-4D30-9268-39DA58DDF114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2754713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S2.</a:t>
            </a:r>
            <a:r>
              <a:rPr lang="en-CA" sz="1200" b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acterial and eukaryotic classes in soil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sz="1200" b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 -</a:t>
            </a:r>
            <a:r>
              <a:rPr lang="en-CA" sz="1200" b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bacterial classes that were differentially represented between orchard soil and uncultivated soil. Corrected P-values (q-values) were calculated based on </a:t>
            </a:r>
            <a:r>
              <a:rPr lang="en-CA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enjamini</a:t>
            </a:r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Hochberg FDR multiple test correction. Features with (Welch's t-test) </a:t>
            </a:r>
            <a:r>
              <a:rPr lang="en-CA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value &lt; 0.05 were considered significant and were thus retained. Only taxa represented by at least 3% </a:t>
            </a:r>
            <a:r>
              <a:rPr lang="en-CA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 16S reads in at least one niche are shown</a:t>
            </a:r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B -</a:t>
            </a:r>
            <a:r>
              <a:rPr lang="en-CA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eukaryotic classes that were differentially represented between orchard soil and uncultivated soil. Corrected P-values (q-values) were calculated based on </a:t>
            </a:r>
            <a:r>
              <a:rPr lang="en-CA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enjamini</a:t>
            </a:r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Hochberg FDR multiple test correction. Features with (Welch's t-test) </a:t>
            </a:r>
            <a:r>
              <a:rPr lang="en-CA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value &lt; 0.05 were considered significant and were thus retained. Only classes represented by at least 1% of 18S </a:t>
            </a:r>
            <a:r>
              <a:rPr lang="en-CA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ads in at least one niche are shown</a:t>
            </a:r>
            <a:r>
              <a:rPr lang="en-CA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CA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CA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014533-58CC-4D30-9268-39DA58DDF114}" type="slidenum">
              <a:rPr lang="en-CA" smtClean="0"/>
              <a:t>2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8956290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S3. </a:t>
            </a:r>
            <a:r>
              <a:rPr lang="en-CA" sz="1200" b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cterial and fungal classes in orchard sample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 - </a:t>
            </a:r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bacterial classes that were differentially represented between apple roots and orchard soil. Corrected P-values (q-values) were calculated based on </a:t>
            </a:r>
            <a:r>
              <a:rPr lang="en-CA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enjamini</a:t>
            </a:r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Hochberg FDR multiple test correction. Features with (Welch's t-test) </a:t>
            </a:r>
            <a:r>
              <a:rPr lang="en-CA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value &lt; 0.05 were considered significant and were thus retained. Only taxa represented by at least 2% of 16S reads </a:t>
            </a:r>
            <a:r>
              <a:rPr lang="en-CA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 at least one niche are shown</a:t>
            </a:r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B -</a:t>
            </a:r>
            <a:r>
              <a:rPr lang="en-CA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fungal classes that were differentially represented between apple roots and orchard soil. Corrected P-values (q-values) were calculated based on </a:t>
            </a:r>
            <a:r>
              <a:rPr lang="en-CA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enjamini</a:t>
            </a:r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Hochberg FDR multiple test correction. Features with (Welch's t-test) </a:t>
            </a:r>
            <a:r>
              <a:rPr lang="en-CA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value &lt; 0.05 were considered significant and were thus retained. Only classes represented by at least 2% </a:t>
            </a:r>
            <a:r>
              <a:rPr lang="en-CA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 ITS reads in at least one niche are shown</a:t>
            </a:r>
            <a:r>
              <a:rPr lang="en-CA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014533-58CC-4D30-9268-39DA58DDF114}" type="slidenum">
              <a:rPr lang="en-CA" smtClean="0"/>
              <a:t>3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51728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6BCA60-5B0F-A42F-D0A8-D078710A9E6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347B9E4-CF55-331A-302C-4EE3389819F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F49641-6C21-4106-2917-FFCAEA8D31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F2E13-57C3-4EF4-A24A-A9342B8D7A79}" type="datetimeFigureOut">
              <a:rPr lang="en-CA" smtClean="0"/>
              <a:t>2023-04-25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A58141-B59A-0E0B-E348-ADAE2E39AD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BBD822-7DA7-26D4-FB5C-B5DB77D4F8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D0D4E-A2F8-40A5-97E2-6DB338AF2A5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81331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EF9D9E-F218-4A52-B501-B46118EE11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24CF18B-D4FF-7412-6EDF-057923D5C6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0CD877-E72F-FEF9-F2C4-78DFD29DB4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F2E13-57C3-4EF4-A24A-A9342B8D7A79}" type="datetimeFigureOut">
              <a:rPr lang="en-CA" smtClean="0"/>
              <a:t>2023-04-25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0FDDB3-2FB4-E1E6-C214-54230D903C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D5A511-9504-8863-BEFA-0B9F7994B1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D0D4E-A2F8-40A5-97E2-6DB338AF2A5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908798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EA20475-33F3-B1DF-E6DD-479D44FF793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6A109EF-5076-02C5-7EDA-1648739737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45ABD5-8491-72DC-64CA-DA897F07E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F2E13-57C3-4EF4-A24A-A9342B8D7A79}" type="datetimeFigureOut">
              <a:rPr lang="en-CA" smtClean="0"/>
              <a:t>2023-04-25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05C7DF-E44D-5D63-AC11-DA673C89B0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B54D95-92F6-59CC-6BEA-DF57F6A37D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D0D4E-A2F8-40A5-97E2-6DB338AF2A5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095825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59C94C-D906-F1F4-3CE5-E13E503A47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309333-E590-1EDB-580F-673F77364E4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887556-F171-41E9-E08D-346AA70976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F2E13-57C3-4EF4-A24A-A9342B8D7A79}" type="datetimeFigureOut">
              <a:rPr lang="en-CA" smtClean="0"/>
              <a:t>2023-04-25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3D801C-BBFF-EFC9-1FC7-9C5C23C596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DA0762-5313-F644-4F8A-85E7BBD4DD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D0D4E-A2F8-40A5-97E2-6DB338AF2A5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97072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CD58E1-0A45-3DAE-178A-85918E5516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3F3079-044B-5F62-F08F-50B36E797A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94A2CF-C7DF-42A3-DC46-0196C5C7E2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F2E13-57C3-4EF4-A24A-A9342B8D7A79}" type="datetimeFigureOut">
              <a:rPr lang="en-CA" smtClean="0"/>
              <a:t>2023-04-25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A0ABDE-54F7-6201-3867-2B870EE29B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E330FF-82DE-48DA-EDA1-52E557B0D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D0D4E-A2F8-40A5-97E2-6DB338AF2A5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94687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97715F-0028-8D3B-15C1-F0C527646E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766350-40FA-6EB1-133F-E8FAF24E86B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A90390D-12EB-E7B4-5736-78921D4E8A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A5BD6CA-DEA5-F760-6F49-F843901DDF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F2E13-57C3-4EF4-A24A-A9342B8D7A79}" type="datetimeFigureOut">
              <a:rPr lang="en-CA" smtClean="0"/>
              <a:t>2023-04-25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589989-73E4-DC9F-1F8E-0C3AF42319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0010F9-E57A-CB13-3B32-3484740FBD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D0D4E-A2F8-40A5-97E2-6DB338AF2A5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505212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04DA03-FF4F-9D4C-45E6-FF7012FCA3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ED191FA-09E1-470D-F04C-29FDE0139D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A2F914-FDEE-890D-B85F-3AC0D8DB0E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F236EE1-CB5A-AF7C-D22D-41E3C1433C8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E9794BA-D0A5-194E-8149-BA3F6C8A859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9A67A71-B69C-1DF2-16B2-91DE0B22EF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F2E13-57C3-4EF4-A24A-A9342B8D7A79}" type="datetimeFigureOut">
              <a:rPr lang="en-CA" smtClean="0"/>
              <a:t>2023-04-25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0CBB0CA-C60B-DFEA-B486-3749DFF642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28BC50D-9BC5-10EA-46DD-8BCBB44367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D0D4E-A2F8-40A5-97E2-6DB338AF2A5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389890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6DC715-5FE2-CBF1-FFF1-5403722444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33ECF78-E647-2D55-51B3-1673C3BD08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F2E13-57C3-4EF4-A24A-A9342B8D7A79}" type="datetimeFigureOut">
              <a:rPr lang="en-CA" smtClean="0"/>
              <a:t>2023-04-25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8B49523-05EF-6128-DA01-BF11F28654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0FF2AB8-C9CD-1620-4802-B6BD63504D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D0D4E-A2F8-40A5-97E2-6DB338AF2A5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259576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931A70C-D5A0-BB5C-88EA-150EC24E8B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F2E13-57C3-4EF4-A24A-A9342B8D7A79}" type="datetimeFigureOut">
              <a:rPr lang="en-CA" smtClean="0"/>
              <a:t>2023-04-25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BF0F187-951E-3ED9-595F-C38A827B1B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56CD327-ABF0-42A6-5490-555F2A687F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D0D4E-A2F8-40A5-97E2-6DB338AF2A5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105542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9F3E45-F0DD-C681-1879-8A4C02C918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0F650A6-33F3-6DBD-6051-0AE7FE91E9D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942AE20-75DB-8A2F-A0ED-51092C8AFD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627A34-BC43-AAFB-2FE3-68D7604D99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F2E13-57C3-4EF4-A24A-A9342B8D7A79}" type="datetimeFigureOut">
              <a:rPr lang="en-CA" smtClean="0"/>
              <a:t>2023-04-25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34B499-D102-C407-8871-7DC5AC0ECD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A9ED65-8A00-80E4-10BC-656E93026D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D0D4E-A2F8-40A5-97E2-6DB338AF2A5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249067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4315EB-90B6-7B0E-F655-7A267FB1A2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95E42C9-325E-C6C0-E764-3A61EBEB01B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06AE0FE-6E70-6DCF-56CD-5C25F74C3D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2E1F834-26E4-160D-7ECA-C5B60A5766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F2E13-57C3-4EF4-A24A-A9342B8D7A79}" type="datetimeFigureOut">
              <a:rPr lang="en-CA" smtClean="0"/>
              <a:t>2023-04-25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5575B58-15D0-88D9-48B7-3EC7FA5528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3F7778-D90E-C00A-7904-7DA3679141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D0D4E-A2F8-40A5-97E2-6DB338AF2A5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625904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36E6849-2C14-AC4B-3AF1-B1A3B2EF74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16E9D4-5C04-4567-2FF3-D172914B58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4A439B-BB1D-9BB7-9D63-E9A06D65353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EF2E13-57C3-4EF4-A24A-A9342B8D7A79}" type="datetimeFigureOut">
              <a:rPr lang="en-CA" smtClean="0"/>
              <a:t>2023-04-25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3BC0CC-C9E0-9830-3226-6DB1505EE43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D5B997-48F6-5243-D513-DA4A123D98C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FD0D4E-A2F8-40A5-97E2-6DB338AF2A5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2445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2F8B2494-7FD0-45C1-B756-5E1F361B30D8}"/>
              </a:ext>
            </a:extLst>
          </p:cNvPr>
          <p:cNvGraphicFramePr/>
          <p:nvPr/>
        </p:nvGraphicFramePr>
        <p:xfrm>
          <a:off x="721895" y="-1"/>
          <a:ext cx="5827761" cy="61846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7602DEE5-7B21-1D50-FC0D-BE756E2A76A0}"/>
              </a:ext>
            </a:extLst>
          </p:cNvPr>
          <p:cNvSpPr txBox="1"/>
          <p:nvPr/>
        </p:nvSpPr>
        <p:spPr>
          <a:xfrm>
            <a:off x="371445" y="240632"/>
            <a:ext cx="400110" cy="418576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CA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mean frequencies </a:t>
            </a:r>
          </a:p>
        </p:txBody>
      </p:sp>
    </p:spTree>
    <p:extLst>
      <p:ext uri="{BB962C8B-B14F-4D97-AF65-F5344CB8AC3E}">
        <p14:creationId xmlns:p14="http://schemas.microsoft.com/office/powerpoint/2010/main" val="13291059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91EC1EE5-14CF-8032-E7EF-108913206DD9}"/>
              </a:ext>
            </a:extLst>
          </p:cNvPr>
          <p:cNvSpPr txBox="1"/>
          <p:nvPr/>
        </p:nvSpPr>
        <p:spPr>
          <a:xfrm>
            <a:off x="0" y="-65851"/>
            <a:ext cx="79802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b="1" dirty="0"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CA" sz="1800" b="1" dirty="0"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CA" dirty="0"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E9E1F33-7568-F1CA-F56C-0B55F131D97F}"/>
              </a:ext>
            </a:extLst>
          </p:cNvPr>
          <p:cNvSpPr txBox="1"/>
          <p:nvPr/>
        </p:nvSpPr>
        <p:spPr>
          <a:xfrm>
            <a:off x="6330222" y="-73913"/>
            <a:ext cx="347025" cy="37214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800" b="1" dirty="0"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B </a:t>
            </a:r>
            <a:endParaRPr lang="en-CA" dirty="0"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0762A74-39EE-9356-5A72-B3BC1212A451}"/>
              </a:ext>
            </a:extLst>
          </p:cNvPr>
          <p:cNvSpPr txBox="1"/>
          <p:nvPr/>
        </p:nvSpPr>
        <p:spPr>
          <a:xfrm>
            <a:off x="1517488" y="4583878"/>
            <a:ext cx="3011170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CA" sz="1600" dirty="0">
                <a:cs typeface="Times New Roman" panose="02020603050405020304" pitchFamily="18" charset="0"/>
              </a:rPr>
              <a:t>Relative mean </a:t>
            </a:r>
            <a:r>
              <a:rPr lang="en-CA" sz="1400" dirty="0">
                <a:cs typeface="Times New Roman" panose="02020603050405020304" pitchFamily="18" charset="0"/>
              </a:rPr>
              <a:t>frequencies</a:t>
            </a:r>
            <a:r>
              <a:rPr lang="en-CA" sz="1600" dirty="0">
                <a:cs typeface="Times New Roman" panose="02020603050405020304" pitchFamily="18" charset="0"/>
              </a:rPr>
              <a:t> (%)</a:t>
            </a:r>
          </a:p>
        </p:txBody>
      </p:sp>
      <p:pic>
        <p:nvPicPr>
          <p:cNvPr id="3" name="Picture 2" descr="Chart, bar chart&#10;&#10;Description automatically generated">
            <a:extLst>
              <a:ext uri="{FF2B5EF4-FFF2-40B4-BE49-F238E27FC236}">
                <a16:creationId xmlns:a16="http://schemas.microsoft.com/office/drawing/2014/main" id="{9EFB6CA4-8482-61EB-0271-CF37A9B18A0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367"/>
          <a:stretch/>
        </p:blipFill>
        <p:spPr bwMode="auto">
          <a:xfrm>
            <a:off x="5932194" y="247953"/>
            <a:ext cx="6022496" cy="5099276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88E3A30-A95F-F0CA-980C-EA322433E49E}"/>
              </a:ext>
            </a:extLst>
          </p:cNvPr>
          <p:cNvSpPr txBox="1"/>
          <p:nvPr/>
        </p:nvSpPr>
        <p:spPr>
          <a:xfrm>
            <a:off x="7685409" y="5372489"/>
            <a:ext cx="301117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CA" sz="1400" dirty="0">
                <a:cs typeface="Times New Roman" panose="02020603050405020304" pitchFamily="18" charset="0"/>
              </a:rPr>
              <a:t>Relative mean frequencies (%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AB3E799-252E-B5D1-D391-E4CB2327A32B}"/>
              </a:ext>
            </a:extLst>
          </p:cNvPr>
          <p:cNvSpPr txBox="1"/>
          <p:nvPr/>
        </p:nvSpPr>
        <p:spPr>
          <a:xfrm>
            <a:off x="3932739" y="2624658"/>
            <a:ext cx="116393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CA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32B3D41-DEC7-A3A6-FB27-084CCD473883}"/>
              </a:ext>
            </a:extLst>
          </p:cNvPr>
          <p:cNvSpPr txBox="1"/>
          <p:nvPr/>
        </p:nvSpPr>
        <p:spPr>
          <a:xfrm>
            <a:off x="4063667" y="1785889"/>
            <a:ext cx="104537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CA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8ACB852-F5F1-993B-1EAE-614DC619BACF}"/>
              </a:ext>
            </a:extLst>
          </p:cNvPr>
          <p:cNvSpPr txBox="1"/>
          <p:nvPr/>
        </p:nvSpPr>
        <p:spPr>
          <a:xfrm>
            <a:off x="4460354" y="2036660"/>
            <a:ext cx="1460439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CA" sz="1400" dirty="0">
                <a:cs typeface="Times New Roman" panose="02020603050405020304" pitchFamily="18" charset="0"/>
              </a:rPr>
              <a:t>Uncultivated soil</a:t>
            </a:r>
          </a:p>
          <a:p>
            <a:r>
              <a:rPr lang="en-CA" sz="1400" dirty="0">
                <a:cs typeface="Times New Roman" panose="02020603050405020304" pitchFamily="18" charset="0"/>
              </a:rPr>
              <a:t>Orchard soil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847D7CAC-E1B4-3852-9536-35AC7D94546D}"/>
              </a:ext>
            </a:extLst>
          </p:cNvPr>
          <p:cNvSpPr/>
          <p:nvPr/>
        </p:nvSpPr>
        <p:spPr>
          <a:xfrm>
            <a:off x="4290027" y="2339921"/>
            <a:ext cx="207772" cy="174684"/>
          </a:xfrm>
          <a:prstGeom prst="rect">
            <a:avLst/>
          </a:prstGeom>
          <a:solidFill>
            <a:srgbClr val="FF7C8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>
              <a:cs typeface="Times New Roman" panose="02020603050405020304" pitchFamily="18" charset="0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B199276E-FB28-B3F4-8BF6-B8A284EAF55A}"/>
              </a:ext>
            </a:extLst>
          </p:cNvPr>
          <p:cNvSpPr/>
          <p:nvPr/>
        </p:nvSpPr>
        <p:spPr>
          <a:xfrm>
            <a:off x="4283062" y="2109579"/>
            <a:ext cx="207772" cy="174684"/>
          </a:xfrm>
          <a:prstGeom prst="rect">
            <a:avLst/>
          </a:prstGeom>
          <a:solidFill>
            <a:srgbClr val="33CCCC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36FFCB6-A250-79AA-5DB3-0DB22E7553F6}"/>
              </a:ext>
            </a:extLst>
          </p:cNvPr>
          <p:cNvSpPr txBox="1"/>
          <p:nvPr/>
        </p:nvSpPr>
        <p:spPr>
          <a:xfrm>
            <a:off x="4460354" y="1752835"/>
            <a:ext cx="86808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dirty="0">
                <a:cs typeface="Times New Roman" panose="02020603050405020304" pitchFamily="18" charset="0"/>
              </a:rPr>
              <a:t>Nich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50BFE0F-8602-42B1-4751-F7CD717C1270}"/>
              </a:ext>
            </a:extLst>
          </p:cNvPr>
          <p:cNvSpPr txBox="1"/>
          <p:nvPr/>
        </p:nvSpPr>
        <p:spPr>
          <a:xfrm>
            <a:off x="10728823" y="2421392"/>
            <a:ext cx="1258226" cy="72871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CA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F9918CD-4BD6-46AC-3A93-071B5CF8DC1A}"/>
              </a:ext>
            </a:extLst>
          </p:cNvPr>
          <p:cNvSpPr txBox="1"/>
          <p:nvPr/>
        </p:nvSpPr>
        <p:spPr>
          <a:xfrm>
            <a:off x="10773427" y="1911492"/>
            <a:ext cx="1412059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CA" sz="1400" dirty="0">
                <a:cs typeface="Times New Roman" panose="02020603050405020304" pitchFamily="18" charset="0"/>
              </a:rPr>
              <a:t>Uncultivated soil</a:t>
            </a:r>
          </a:p>
          <a:p>
            <a:r>
              <a:rPr lang="en-CA" sz="1400" dirty="0">
                <a:cs typeface="Times New Roman" panose="02020603050405020304" pitchFamily="18" charset="0"/>
              </a:rPr>
              <a:t>Orchard soil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94AD6B6F-77D0-9E65-E559-CD39C069C116}"/>
              </a:ext>
            </a:extLst>
          </p:cNvPr>
          <p:cNvSpPr/>
          <p:nvPr/>
        </p:nvSpPr>
        <p:spPr>
          <a:xfrm>
            <a:off x="10603100" y="2214753"/>
            <a:ext cx="200889" cy="174684"/>
          </a:xfrm>
          <a:prstGeom prst="rect">
            <a:avLst/>
          </a:prstGeom>
          <a:solidFill>
            <a:srgbClr val="FF7C8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>
              <a:cs typeface="Times New Roman" panose="02020603050405020304" pitchFamily="18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C6782A10-8F7C-0481-65F5-0DBD79EE0174}"/>
              </a:ext>
            </a:extLst>
          </p:cNvPr>
          <p:cNvSpPr/>
          <p:nvPr/>
        </p:nvSpPr>
        <p:spPr>
          <a:xfrm>
            <a:off x="10596135" y="1984411"/>
            <a:ext cx="200889" cy="174684"/>
          </a:xfrm>
          <a:prstGeom prst="rect">
            <a:avLst/>
          </a:prstGeom>
          <a:solidFill>
            <a:srgbClr val="33CCCC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100B39E-70E5-623F-91F3-7B05DA02037D}"/>
              </a:ext>
            </a:extLst>
          </p:cNvPr>
          <p:cNvSpPr txBox="1"/>
          <p:nvPr/>
        </p:nvSpPr>
        <p:spPr>
          <a:xfrm>
            <a:off x="10773427" y="1627672"/>
            <a:ext cx="83932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dirty="0">
                <a:cs typeface="Times New Roman" panose="02020603050405020304" pitchFamily="18" charset="0"/>
              </a:rPr>
              <a:t>Niche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F0E1D47-44F4-3D53-B3CA-9A95CEB8AB48}"/>
              </a:ext>
            </a:extLst>
          </p:cNvPr>
          <p:cNvSpPr txBox="1"/>
          <p:nvPr/>
        </p:nvSpPr>
        <p:spPr>
          <a:xfrm>
            <a:off x="6514" y="1667692"/>
            <a:ext cx="400110" cy="631825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r>
              <a:rPr lang="en-CA" sz="1400" dirty="0">
                <a:cs typeface="Times New Roman" panose="02020603050405020304" pitchFamily="18" charset="0"/>
              </a:rPr>
              <a:t>Tax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B4A2316-C531-440F-3545-4E37F7F73992}"/>
              </a:ext>
            </a:extLst>
          </p:cNvPr>
          <p:cNvSpPr txBox="1"/>
          <p:nvPr/>
        </p:nvSpPr>
        <p:spPr>
          <a:xfrm>
            <a:off x="5688742" y="608788"/>
            <a:ext cx="400110" cy="1457045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r>
              <a:rPr lang="en-CA" sz="1400" dirty="0">
                <a:cs typeface="Times New Roman" panose="02020603050405020304" pitchFamily="18" charset="0"/>
              </a:rPr>
              <a:t>              Taxa</a:t>
            </a:r>
          </a:p>
        </p:txBody>
      </p:sp>
      <p:pic>
        <p:nvPicPr>
          <p:cNvPr id="13" name="Picture 12" descr="Chart, bar chart&#10;&#10;Description automatically generated">
            <a:extLst>
              <a:ext uri="{FF2B5EF4-FFF2-40B4-BE49-F238E27FC236}">
                <a16:creationId xmlns:a16="http://schemas.microsoft.com/office/drawing/2014/main" id="{7AD4BB95-2741-C4B7-9950-1EADE2617D3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5" t="5077" r="24423" b="4868"/>
          <a:stretch/>
        </p:blipFill>
        <p:spPr>
          <a:xfrm>
            <a:off x="307924" y="228344"/>
            <a:ext cx="3830350" cy="429904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EEC38EA-B201-DD85-CB87-9A1C9C4323B5}"/>
              </a:ext>
            </a:extLst>
          </p:cNvPr>
          <p:cNvSpPr txBox="1"/>
          <p:nvPr/>
        </p:nvSpPr>
        <p:spPr>
          <a:xfrm>
            <a:off x="352053" y="364355"/>
            <a:ext cx="1165435" cy="397031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CA" dirty="0"/>
          </a:p>
          <a:p>
            <a:endParaRPr lang="en-CA" dirty="0"/>
          </a:p>
          <a:p>
            <a:endParaRPr lang="en-CA" dirty="0"/>
          </a:p>
          <a:p>
            <a:endParaRPr lang="en-CA" dirty="0"/>
          </a:p>
          <a:p>
            <a:endParaRPr lang="en-CA" dirty="0"/>
          </a:p>
          <a:p>
            <a:endParaRPr lang="en-CA" dirty="0"/>
          </a:p>
          <a:p>
            <a:endParaRPr lang="en-CA" dirty="0"/>
          </a:p>
          <a:p>
            <a:endParaRPr lang="en-CA" dirty="0"/>
          </a:p>
          <a:p>
            <a:endParaRPr lang="en-CA" dirty="0"/>
          </a:p>
          <a:p>
            <a:endParaRPr lang="en-CA" dirty="0"/>
          </a:p>
          <a:p>
            <a:endParaRPr lang="en-CA" dirty="0"/>
          </a:p>
          <a:p>
            <a:endParaRPr lang="en-CA" dirty="0"/>
          </a:p>
          <a:p>
            <a:endParaRPr lang="en-CA" dirty="0"/>
          </a:p>
          <a:p>
            <a:endParaRPr lang="en-CA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1435810-F5A6-081D-788C-FE3CC74CE2F2}"/>
              </a:ext>
            </a:extLst>
          </p:cNvPr>
          <p:cNvSpPr txBox="1"/>
          <p:nvPr/>
        </p:nvSpPr>
        <p:spPr>
          <a:xfrm>
            <a:off x="109487" y="326414"/>
            <a:ext cx="1502400" cy="3980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ts val="16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Acidobacteriae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16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Alphaproteobacteria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16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Verrucomicrobiae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1600"/>
              </a:lnSpc>
              <a:spcAft>
                <a:spcPts val="800"/>
              </a:spcAft>
            </a:pPr>
            <a:r>
              <a:rPr lang="en-CA" sz="1200" kern="100" dirty="0">
                <a:effectLst/>
                <a:ea typeface="Calibri" panose="020F0502020204030204" pitchFamily="34" charset="0"/>
              </a:rPr>
              <a:t>AD3</a:t>
            </a:r>
          </a:p>
          <a:p>
            <a:pPr algn="r">
              <a:lnSpc>
                <a:spcPts val="1600"/>
              </a:lnSpc>
              <a:spcAft>
                <a:spcPts val="800"/>
              </a:spcAft>
            </a:pPr>
            <a:r>
              <a:rPr lang="en-CA" sz="1200" kern="100" dirty="0">
                <a:effectLst/>
                <a:ea typeface="Calibri" panose="020F0502020204030204" pitchFamily="34" charset="0"/>
              </a:rPr>
              <a:t>RCP2-54</a:t>
            </a:r>
          </a:p>
          <a:p>
            <a:pPr algn="r">
              <a:lnSpc>
                <a:spcPts val="1600"/>
              </a:lnSpc>
              <a:spcAft>
                <a:spcPts val="800"/>
              </a:spcAft>
            </a:pPr>
            <a:r>
              <a:rPr lang="en-CA" sz="1200" kern="100" dirty="0">
                <a:effectLst/>
                <a:ea typeface="Calibri" panose="020F0502020204030204" pitchFamily="34" charset="0"/>
              </a:rPr>
              <a:t>Actinobacteria</a:t>
            </a:r>
          </a:p>
          <a:p>
            <a:pPr algn="r">
              <a:lnSpc>
                <a:spcPts val="16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Vicinamibacteria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16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Acidimicrobiia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16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Gemmatimonadetes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16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Thermoleophilia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16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Polyangia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1600"/>
              </a:lnSpc>
              <a:spcAft>
                <a:spcPts val="800"/>
              </a:spcAft>
            </a:pPr>
            <a:r>
              <a:rPr lang="en-CA" sz="1200" kern="100" dirty="0">
                <a:effectLst/>
                <a:ea typeface="Calibri" panose="020F0502020204030204" pitchFamily="34" charset="0"/>
              </a:rPr>
              <a:t>KD4-96</a:t>
            </a:r>
          </a:p>
          <a:p>
            <a:pPr algn="r">
              <a:lnSpc>
                <a:spcPts val="1600"/>
              </a:lnSpc>
              <a:spcAft>
                <a:spcPts val="800"/>
              </a:spcAft>
            </a:pPr>
            <a:r>
              <a:rPr lang="en-CA" sz="1200" kern="100" dirty="0">
                <a:effectLst/>
                <a:ea typeface="Calibri" panose="020F0502020204030204" pitchFamily="34" charset="0"/>
              </a:rPr>
              <a:t>MB-A2-108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4B75314-09E5-3B32-2A23-69D07B3EFA87}"/>
              </a:ext>
            </a:extLst>
          </p:cNvPr>
          <p:cNvSpPr txBox="1"/>
          <p:nvPr/>
        </p:nvSpPr>
        <p:spPr>
          <a:xfrm>
            <a:off x="1574133" y="4311566"/>
            <a:ext cx="262014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CA" sz="1200" dirty="0"/>
              <a:t>0    4    8   12  16 20 24 28 32 36 40 44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68FA29B-387E-73A6-441D-167C72F3B001}"/>
              </a:ext>
            </a:extLst>
          </p:cNvPr>
          <p:cNvSpPr txBox="1"/>
          <p:nvPr/>
        </p:nvSpPr>
        <p:spPr>
          <a:xfrm>
            <a:off x="7270595" y="5113061"/>
            <a:ext cx="332554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CA" sz="1200" dirty="0"/>
              <a:t>0    1     2     3     4      5     6    7     8     9    10   11  1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A6185BD-6576-5A8A-9E0D-067CF7E4BDFC}"/>
              </a:ext>
            </a:extLst>
          </p:cNvPr>
          <p:cNvSpPr txBox="1"/>
          <p:nvPr/>
        </p:nvSpPr>
        <p:spPr>
          <a:xfrm>
            <a:off x="6144607" y="228344"/>
            <a:ext cx="1029849" cy="488471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CA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456CF3E-84EF-1E8B-7E23-9062A5AB41E5}"/>
              </a:ext>
            </a:extLst>
          </p:cNvPr>
          <p:cNvSpPr txBox="1"/>
          <p:nvPr/>
        </p:nvSpPr>
        <p:spPr>
          <a:xfrm>
            <a:off x="5867059" y="2298270"/>
            <a:ext cx="375814" cy="6957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CA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4C5ED14-6213-186B-677D-5341276840D9}"/>
              </a:ext>
            </a:extLst>
          </p:cNvPr>
          <p:cNvSpPr txBox="1"/>
          <p:nvPr/>
        </p:nvSpPr>
        <p:spPr>
          <a:xfrm>
            <a:off x="5712859" y="324982"/>
            <a:ext cx="1563315" cy="48123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>
              <a:lnSpc>
                <a:spcPts val="7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Sordariomycetes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700"/>
              </a:lnSpc>
              <a:spcAft>
                <a:spcPts val="800"/>
              </a:spcAft>
            </a:pPr>
            <a:r>
              <a:rPr lang="en-CA" sz="1200" kern="100" dirty="0">
                <a:effectLst/>
                <a:ea typeface="Calibri" panose="020F0502020204030204" pitchFamily="34" charset="0"/>
              </a:rPr>
              <a:t>Chlorophyceae</a:t>
            </a:r>
          </a:p>
          <a:p>
            <a:pPr algn="r">
              <a:lnSpc>
                <a:spcPts val="7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Glissomonadida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7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Leotiomycetes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7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Dothideomycetes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7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Cercomonadidae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7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Cercozoa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7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Eurotiomycetes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7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Trebouxiophyceae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7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Saccharomycetes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7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Conoidasida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7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Klebsormidiophyceae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7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Intramacronucleata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700"/>
              </a:lnSpc>
              <a:spcAft>
                <a:spcPts val="800"/>
              </a:spcAft>
            </a:pPr>
            <a:r>
              <a:rPr lang="en-CA" sz="1200" kern="100" dirty="0">
                <a:effectLst/>
                <a:ea typeface="Calibri" panose="020F0502020204030204" pitchFamily="34" charset="0"/>
              </a:rPr>
              <a:t>Arachnida</a:t>
            </a:r>
          </a:p>
          <a:p>
            <a:pPr algn="r">
              <a:lnSpc>
                <a:spcPts val="700"/>
              </a:lnSpc>
              <a:spcAft>
                <a:spcPts val="800"/>
              </a:spcAft>
            </a:pPr>
            <a:r>
              <a:rPr lang="en-CA" sz="1200" kern="100" dirty="0">
                <a:effectLst/>
                <a:ea typeface="Calibri" panose="020F0502020204030204" pitchFamily="34" charset="0"/>
              </a:rPr>
              <a:t>Agaricomycetes</a:t>
            </a:r>
          </a:p>
          <a:p>
            <a:pPr algn="r">
              <a:lnSpc>
                <a:spcPts val="700"/>
              </a:lnSpc>
              <a:spcAft>
                <a:spcPts val="800"/>
              </a:spcAft>
            </a:pPr>
            <a:r>
              <a:rPr lang="en-CA" sz="1200" kern="100" dirty="0">
                <a:effectLst/>
                <a:ea typeface="Calibri" panose="020F0502020204030204" pitchFamily="34" charset="0"/>
              </a:rPr>
              <a:t>Bacillariophyceae</a:t>
            </a:r>
          </a:p>
          <a:p>
            <a:pPr algn="r">
              <a:lnSpc>
                <a:spcPts val="700"/>
              </a:lnSpc>
              <a:spcAft>
                <a:spcPts val="800"/>
              </a:spcAft>
            </a:pPr>
            <a:r>
              <a:rPr lang="en-CA" sz="1200" kern="100" dirty="0">
                <a:effectLst/>
                <a:ea typeface="Calibri" panose="020F0502020204030204" pitchFamily="34" charset="0"/>
              </a:rPr>
              <a:t>Dinophyceae</a:t>
            </a:r>
          </a:p>
          <a:p>
            <a:pPr algn="r">
              <a:lnSpc>
                <a:spcPts val="7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Syndiniales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7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Rhabditophora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7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Prymnesiophyceae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7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Maxillopoda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7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Dinoflagellata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7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Archaeorhizomycetes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700"/>
              </a:lnSpc>
              <a:spcAft>
                <a:spcPts val="800"/>
              </a:spcAft>
            </a:pPr>
            <a:r>
              <a:rPr lang="en-CA" sz="1200" kern="100" dirty="0">
                <a:effectLst/>
                <a:ea typeface="Calibri" panose="020F0502020204030204" pitchFamily="34" charset="0"/>
              </a:rPr>
              <a:t>Appendicularia</a:t>
            </a:r>
          </a:p>
          <a:p>
            <a:pPr algn="r">
              <a:lnSpc>
                <a:spcPts val="7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Acantharia</a:t>
            </a:r>
            <a:endParaRPr lang="en-CA" sz="1200" kern="100" dirty="0">
              <a:effectLst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429821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hart, bar chart&#10;&#10;Description automatically generated">
            <a:extLst>
              <a:ext uri="{FF2B5EF4-FFF2-40B4-BE49-F238E27FC236}">
                <a16:creationId xmlns:a16="http://schemas.microsoft.com/office/drawing/2014/main" id="{10EDC195-6255-24C8-498C-DE466272BB5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643"/>
          <a:stretch/>
        </p:blipFill>
        <p:spPr bwMode="auto">
          <a:xfrm>
            <a:off x="6187861" y="101958"/>
            <a:ext cx="5761216" cy="4402173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522649D4-9FD7-3664-08AB-81D8D5E9980E}"/>
              </a:ext>
            </a:extLst>
          </p:cNvPr>
          <p:cNvSpPr txBox="1"/>
          <p:nvPr/>
        </p:nvSpPr>
        <p:spPr>
          <a:xfrm>
            <a:off x="0" y="-95697"/>
            <a:ext cx="40541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800" b="1" dirty="0"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CA" dirty="0"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2EC0E18-B6D0-1DCA-9BDB-A39D8E0A28A5}"/>
              </a:ext>
            </a:extLst>
          </p:cNvPr>
          <p:cNvSpPr txBox="1"/>
          <p:nvPr/>
        </p:nvSpPr>
        <p:spPr>
          <a:xfrm>
            <a:off x="6020469" y="-83242"/>
            <a:ext cx="40011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800" b="1" dirty="0"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B </a:t>
            </a:r>
            <a:endParaRPr lang="en-CA" dirty="0">
              <a:cs typeface="Times New Roman" panose="02020603050405020304" pitchFamily="18" charset="0"/>
            </a:endParaRPr>
          </a:p>
        </p:txBody>
      </p:sp>
      <p:pic>
        <p:nvPicPr>
          <p:cNvPr id="2" name="Picture 1" descr="Chart, bar chart&#10;&#10;Description automatically generated">
            <a:extLst>
              <a:ext uri="{FF2B5EF4-FFF2-40B4-BE49-F238E27FC236}">
                <a16:creationId xmlns:a16="http://schemas.microsoft.com/office/drawing/2014/main" id="{ADDE9781-3A98-0457-FCEC-196394FC2E8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72" b="4738"/>
          <a:stretch/>
        </p:blipFill>
        <p:spPr>
          <a:xfrm>
            <a:off x="-23891" y="191384"/>
            <a:ext cx="6004140" cy="456320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9948325-33E5-AB7D-C70E-CE0D26663538}"/>
              </a:ext>
            </a:extLst>
          </p:cNvPr>
          <p:cNvSpPr txBox="1"/>
          <p:nvPr/>
        </p:nvSpPr>
        <p:spPr>
          <a:xfrm>
            <a:off x="1741691" y="4778474"/>
            <a:ext cx="301117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CA" sz="1400" dirty="0">
                <a:cs typeface="Times New Roman" panose="02020603050405020304" pitchFamily="18" charset="0"/>
              </a:rPr>
              <a:t>Relative mean frequencies (%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3082B0B-0267-1E5B-5BC2-15FDD4D3C582}"/>
              </a:ext>
            </a:extLst>
          </p:cNvPr>
          <p:cNvSpPr txBox="1"/>
          <p:nvPr/>
        </p:nvSpPr>
        <p:spPr>
          <a:xfrm>
            <a:off x="8118104" y="4600587"/>
            <a:ext cx="301117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CA" sz="1400" dirty="0">
                <a:cs typeface="Times New Roman" panose="02020603050405020304" pitchFamily="18" charset="0"/>
              </a:rPr>
              <a:t>Relative mean frequencies (%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2A7ADED-A7AD-FC05-6E7A-04EB62F0E895}"/>
              </a:ext>
            </a:extLst>
          </p:cNvPr>
          <p:cNvSpPr txBox="1"/>
          <p:nvPr/>
        </p:nvSpPr>
        <p:spPr>
          <a:xfrm>
            <a:off x="62617" y="1818436"/>
            <a:ext cx="400110" cy="954107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r>
              <a:rPr lang="en-CA" sz="1400" dirty="0">
                <a:cs typeface="Times New Roman" panose="02020603050405020304" pitchFamily="18" charset="0"/>
              </a:rPr>
              <a:t>Tax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1C3EEEB-4E0C-1CB1-79C5-182F6FDF4E15}"/>
              </a:ext>
            </a:extLst>
          </p:cNvPr>
          <p:cNvSpPr txBox="1"/>
          <p:nvPr/>
        </p:nvSpPr>
        <p:spPr>
          <a:xfrm>
            <a:off x="5072381" y="3171991"/>
            <a:ext cx="1141112" cy="7386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CA" sz="1400" dirty="0">
                <a:cs typeface="Times New Roman" panose="02020603050405020304" pitchFamily="18" charset="0"/>
              </a:rPr>
              <a:t>Niche</a:t>
            </a:r>
          </a:p>
          <a:p>
            <a:r>
              <a:rPr lang="en-CA" sz="1400" dirty="0">
                <a:cs typeface="Times New Roman" panose="02020603050405020304" pitchFamily="18" charset="0"/>
              </a:rPr>
              <a:t>Apple roots</a:t>
            </a:r>
          </a:p>
          <a:p>
            <a:r>
              <a:rPr lang="en-CA" sz="1400" dirty="0">
                <a:cs typeface="Times New Roman" panose="02020603050405020304" pitchFamily="18" charset="0"/>
              </a:rPr>
              <a:t>Orchard soil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B0E95448-D332-D972-ADF2-1DBEB0F3F62B}"/>
              </a:ext>
            </a:extLst>
          </p:cNvPr>
          <p:cNvSpPr/>
          <p:nvPr/>
        </p:nvSpPr>
        <p:spPr>
          <a:xfrm>
            <a:off x="4893456" y="3549295"/>
            <a:ext cx="182596" cy="136559"/>
          </a:xfrm>
          <a:prstGeom prst="rect">
            <a:avLst/>
          </a:prstGeom>
          <a:solidFill>
            <a:srgbClr val="FF7C8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5080CFD7-941A-B162-7CC2-300F7AE41417}"/>
              </a:ext>
            </a:extLst>
          </p:cNvPr>
          <p:cNvSpPr/>
          <p:nvPr/>
        </p:nvSpPr>
        <p:spPr>
          <a:xfrm>
            <a:off x="4889785" y="3768101"/>
            <a:ext cx="182596" cy="136559"/>
          </a:xfrm>
          <a:prstGeom prst="rect">
            <a:avLst/>
          </a:prstGeom>
          <a:solidFill>
            <a:srgbClr val="33CCCC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48C26093-2ADE-9415-1F50-52E515CEC980}"/>
              </a:ext>
            </a:extLst>
          </p:cNvPr>
          <p:cNvSpPr/>
          <p:nvPr/>
        </p:nvSpPr>
        <p:spPr>
          <a:xfrm>
            <a:off x="6147516" y="1993239"/>
            <a:ext cx="400111" cy="95410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AF224EB-FCF1-B0A3-40EC-CB83ACD9C133}"/>
              </a:ext>
            </a:extLst>
          </p:cNvPr>
          <p:cNvSpPr txBox="1"/>
          <p:nvPr/>
        </p:nvSpPr>
        <p:spPr>
          <a:xfrm>
            <a:off x="4752861" y="1993239"/>
            <a:ext cx="1141112" cy="92333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CA" dirty="0"/>
          </a:p>
          <a:p>
            <a:endParaRPr lang="en-CA" dirty="0"/>
          </a:p>
          <a:p>
            <a:endParaRPr lang="en-CA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FE4C072-193E-8AD1-ADDF-5F665AC1070B}"/>
              </a:ext>
            </a:extLst>
          </p:cNvPr>
          <p:cNvSpPr txBox="1"/>
          <p:nvPr/>
        </p:nvSpPr>
        <p:spPr>
          <a:xfrm>
            <a:off x="4722152" y="2127061"/>
            <a:ext cx="167633" cy="161356"/>
          </a:xfrm>
          <a:prstGeom prst="rect">
            <a:avLst/>
          </a:prstGeom>
          <a:solidFill>
            <a:srgbClr val="FF7C80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CA" dirty="0"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DC307F9-EE8C-EC71-9924-1A9107907CAA}"/>
              </a:ext>
            </a:extLst>
          </p:cNvPr>
          <p:cNvSpPr txBox="1"/>
          <p:nvPr/>
        </p:nvSpPr>
        <p:spPr>
          <a:xfrm>
            <a:off x="4722150" y="2392966"/>
            <a:ext cx="167633" cy="161356"/>
          </a:xfrm>
          <a:prstGeom prst="rect">
            <a:avLst/>
          </a:prstGeom>
          <a:solidFill>
            <a:srgbClr val="33CCCC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CA" dirty="0"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BB682A1-A3F3-EE53-91BF-811A7ACDFE50}"/>
              </a:ext>
            </a:extLst>
          </p:cNvPr>
          <p:cNvSpPr txBox="1"/>
          <p:nvPr/>
        </p:nvSpPr>
        <p:spPr>
          <a:xfrm>
            <a:off x="4773849" y="1757754"/>
            <a:ext cx="7291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600" dirty="0">
                <a:cs typeface="Times New Roman" panose="02020603050405020304" pitchFamily="18" charset="0"/>
              </a:rPr>
              <a:t>Nich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6EEA07D-C6FE-4F11-E262-8C8893A7719E}"/>
              </a:ext>
            </a:extLst>
          </p:cNvPr>
          <p:cNvSpPr txBox="1"/>
          <p:nvPr/>
        </p:nvSpPr>
        <p:spPr>
          <a:xfrm>
            <a:off x="4817326" y="2043207"/>
            <a:ext cx="1147782" cy="5661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900"/>
              </a:lnSpc>
            </a:pPr>
            <a:r>
              <a:rPr lang="en-CA" sz="1400" dirty="0">
                <a:cs typeface="Times New Roman" panose="02020603050405020304" pitchFamily="18" charset="0"/>
              </a:rPr>
              <a:t>Apple roots</a:t>
            </a:r>
          </a:p>
          <a:p>
            <a:pPr>
              <a:lnSpc>
                <a:spcPts val="1900"/>
              </a:lnSpc>
            </a:pPr>
            <a:r>
              <a:rPr lang="en-CA" sz="1400" dirty="0">
                <a:cs typeface="Times New Roman" panose="02020603050405020304" pitchFamily="18" charset="0"/>
              </a:rPr>
              <a:t>Orchard soil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F1F54CC-FD2E-CEF1-70A4-4327D044D619}"/>
              </a:ext>
            </a:extLst>
          </p:cNvPr>
          <p:cNvSpPr txBox="1"/>
          <p:nvPr/>
        </p:nvSpPr>
        <p:spPr>
          <a:xfrm>
            <a:off x="4826336" y="3194293"/>
            <a:ext cx="1269664" cy="92333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CA" dirty="0"/>
          </a:p>
          <a:p>
            <a:endParaRPr lang="en-CA" dirty="0"/>
          </a:p>
          <a:p>
            <a:endParaRPr lang="en-CA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631C779-2EE5-BDCC-3B53-742C981E915B}"/>
              </a:ext>
            </a:extLst>
          </p:cNvPr>
          <p:cNvSpPr txBox="1"/>
          <p:nvPr/>
        </p:nvSpPr>
        <p:spPr>
          <a:xfrm>
            <a:off x="10930269" y="1818437"/>
            <a:ext cx="1186199" cy="95410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CA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A2A91E0-29B7-63D0-C8AC-C195EDA1ED38}"/>
              </a:ext>
            </a:extLst>
          </p:cNvPr>
          <p:cNvSpPr txBox="1"/>
          <p:nvPr/>
        </p:nvSpPr>
        <p:spPr>
          <a:xfrm>
            <a:off x="10859154" y="2082455"/>
            <a:ext cx="215087" cy="184327"/>
          </a:xfrm>
          <a:prstGeom prst="rect">
            <a:avLst/>
          </a:prstGeom>
          <a:solidFill>
            <a:srgbClr val="FF7C80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CA" dirty="0">
              <a:cs typeface="Times New Roman" panose="02020603050405020304" pitchFamily="18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37DA271-E2FB-F58E-206C-413C59067F97}"/>
              </a:ext>
            </a:extLst>
          </p:cNvPr>
          <p:cNvSpPr txBox="1"/>
          <p:nvPr/>
        </p:nvSpPr>
        <p:spPr>
          <a:xfrm>
            <a:off x="10859152" y="2340278"/>
            <a:ext cx="215087" cy="184328"/>
          </a:xfrm>
          <a:prstGeom prst="rect">
            <a:avLst/>
          </a:prstGeom>
          <a:solidFill>
            <a:srgbClr val="33CCCC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CA" dirty="0">
              <a:cs typeface="Times New Roman" panose="02020603050405020304" pitchFamily="18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0DB18AA-B576-2F88-3FC3-EEA25031E4E2}"/>
              </a:ext>
            </a:extLst>
          </p:cNvPr>
          <p:cNvSpPr txBox="1"/>
          <p:nvPr/>
        </p:nvSpPr>
        <p:spPr>
          <a:xfrm>
            <a:off x="10937826" y="1737817"/>
            <a:ext cx="6751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dirty="0">
                <a:cs typeface="Times New Roman" panose="02020603050405020304" pitchFamily="18" charset="0"/>
              </a:rPr>
              <a:t>Niche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442A313-E3AE-45EC-E90E-9200C3895B02}"/>
              </a:ext>
            </a:extLst>
          </p:cNvPr>
          <p:cNvSpPr txBox="1"/>
          <p:nvPr/>
        </p:nvSpPr>
        <p:spPr>
          <a:xfrm>
            <a:off x="11018486" y="2023838"/>
            <a:ext cx="1062855" cy="5436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800"/>
              </a:lnSpc>
            </a:pPr>
            <a:r>
              <a:rPr lang="en-CA" sz="1400" dirty="0">
                <a:cs typeface="Times New Roman" panose="02020603050405020304" pitchFamily="18" charset="0"/>
              </a:rPr>
              <a:t>Apple roots</a:t>
            </a:r>
          </a:p>
          <a:p>
            <a:pPr>
              <a:lnSpc>
                <a:spcPts val="1800"/>
              </a:lnSpc>
            </a:pPr>
            <a:r>
              <a:rPr lang="en-CA" sz="1400" dirty="0">
                <a:cs typeface="Times New Roman" panose="02020603050405020304" pitchFamily="18" charset="0"/>
              </a:rPr>
              <a:t>Orchard soi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2FEEE2B-9960-6589-F273-62176E55E61D}"/>
              </a:ext>
            </a:extLst>
          </p:cNvPr>
          <p:cNvSpPr txBox="1"/>
          <p:nvPr/>
        </p:nvSpPr>
        <p:spPr>
          <a:xfrm>
            <a:off x="6033430" y="303543"/>
            <a:ext cx="1878260" cy="445250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>
              <a:lnSpc>
                <a:spcPts val="3100"/>
              </a:lnSpc>
              <a:spcAft>
                <a:spcPts val="800"/>
              </a:spcAft>
            </a:pPr>
            <a:r>
              <a:rPr lang="en-CA" sz="1600" kern="100" dirty="0" err="1">
                <a:effectLst/>
                <a:ea typeface="Calibri" panose="020F0502020204030204" pitchFamily="34" charset="0"/>
              </a:rPr>
              <a:t>Dothideomycetes</a:t>
            </a:r>
            <a:endParaRPr lang="en-CA" sz="16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3100"/>
              </a:lnSpc>
              <a:spcAft>
                <a:spcPts val="800"/>
              </a:spcAft>
            </a:pPr>
            <a:r>
              <a:rPr lang="en-CA" sz="1600" kern="100" dirty="0" err="1">
                <a:effectLst/>
                <a:ea typeface="Calibri" panose="020F0502020204030204" pitchFamily="34" charset="0"/>
              </a:rPr>
              <a:t>Leotiomycetes</a:t>
            </a:r>
            <a:endParaRPr lang="en-CA" sz="16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3100"/>
              </a:lnSpc>
              <a:spcAft>
                <a:spcPts val="800"/>
              </a:spcAft>
            </a:pPr>
            <a:r>
              <a:rPr lang="en-CA" sz="1600" kern="100" dirty="0" err="1">
                <a:effectLst/>
                <a:ea typeface="Calibri" panose="020F0502020204030204" pitchFamily="34" charset="0"/>
              </a:rPr>
              <a:t>Sordariomycetes</a:t>
            </a:r>
            <a:endParaRPr lang="en-CA" sz="16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3100"/>
              </a:lnSpc>
              <a:spcAft>
                <a:spcPts val="800"/>
              </a:spcAft>
            </a:pPr>
            <a:r>
              <a:rPr lang="en-CA" sz="1600" kern="100" dirty="0">
                <a:effectLst/>
                <a:ea typeface="Calibri" panose="020F0502020204030204" pitchFamily="34" charset="0"/>
              </a:rPr>
              <a:t>Ascomycota</a:t>
            </a:r>
          </a:p>
          <a:p>
            <a:pPr algn="r">
              <a:lnSpc>
                <a:spcPts val="3100"/>
              </a:lnSpc>
              <a:spcAft>
                <a:spcPts val="800"/>
              </a:spcAft>
            </a:pPr>
            <a:r>
              <a:rPr lang="en-CA" sz="1600" kern="100" dirty="0" err="1">
                <a:effectLst/>
                <a:ea typeface="Calibri" panose="020F0502020204030204" pitchFamily="34" charset="0"/>
              </a:rPr>
              <a:t>Eurotiomycetes</a:t>
            </a:r>
            <a:endParaRPr lang="en-CA" sz="16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3100"/>
              </a:lnSpc>
              <a:spcAft>
                <a:spcPts val="800"/>
              </a:spcAft>
            </a:pPr>
            <a:r>
              <a:rPr lang="en-CA" sz="1600" kern="100" dirty="0" err="1">
                <a:effectLst/>
                <a:ea typeface="Calibri" panose="020F0502020204030204" pitchFamily="34" charset="0"/>
              </a:rPr>
              <a:t>Tremellomycetes</a:t>
            </a:r>
            <a:endParaRPr lang="en-CA" sz="16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3100"/>
              </a:lnSpc>
              <a:spcAft>
                <a:spcPts val="800"/>
              </a:spcAft>
            </a:pPr>
            <a:r>
              <a:rPr lang="en-CA" sz="1600" kern="100" dirty="0" err="1">
                <a:effectLst/>
                <a:ea typeface="Calibri" panose="020F0502020204030204" pitchFamily="34" charset="0"/>
              </a:rPr>
              <a:t>Mortierellomycetes</a:t>
            </a:r>
            <a:endParaRPr lang="en-CA" sz="16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3100"/>
              </a:lnSpc>
              <a:spcAft>
                <a:spcPts val="800"/>
              </a:spcAft>
            </a:pPr>
            <a:r>
              <a:rPr lang="en-CA" sz="1600" kern="100" dirty="0" err="1">
                <a:effectLst/>
                <a:ea typeface="Calibri" panose="020F0502020204030204" pitchFamily="34" charset="0"/>
              </a:rPr>
              <a:t>Saccharomycetes</a:t>
            </a:r>
            <a:endParaRPr lang="en-CA" sz="16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3100"/>
              </a:lnSpc>
            </a:pPr>
            <a:endParaRPr lang="en-CA" sz="16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0A47189-EB8E-5F24-9428-357685326A37}"/>
              </a:ext>
            </a:extLst>
          </p:cNvPr>
          <p:cNvSpPr txBox="1"/>
          <p:nvPr/>
        </p:nvSpPr>
        <p:spPr>
          <a:xfrm>
            <a:off x="5974131" y="1615399"/>
            <a:ext cx="400110" cy="954107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pPr algn="ctr"/>
            <a:r>
              <a:rPr lang="en-CA" sz="1400" dirty="0">
                <a:cs typeface="Times New Roman" panose="02020603050405020304" pitchFamily="18" charset="0"/>
              </a:rPr>
              <a:t>Tax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F149D74-2F57-E284-19F0-1BEAAB5BBB7B}"/>
              </a:ext>
            </a:extLst>
          </p:cNvPr>
          <p:cNvSpPr txBox="1"/>
          <p:nvPr/>
        </p:nvSpPr>
        <p:spPr>
          <a:xfrm>
            <a:off x="7947718" y="4319051"/>
            <a:ext cx="295603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CA" sz="1200" dirty="0"/>
              <a:t>0     5    10   15  20    25  30   35   40   45   50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1F4168F-E73F-4CA1-E4FA-32FB4DD4C2EC}"/>
              </a:ext>
            </a:extLst>
          </p:cNvPr>
          <p:cNvSpPr txBox="1"/>
          <p:nvPr/>
        </p:nvSpPr>
        <p:spPr>
          <a:xfrm>
            <a:off x="1472701" y="4551446"/>
            <a:ext cx="335821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CA" sz="1200" dirty="0"/>
              <a:t>0          4          8         12        16       20        24       28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0D8C05F-0D16-C9CE-6E4D-8EE69B3F3F8E}"/>
              </a:ext>
            </a:extLst>
          </p:cNvPr>
          <p:cNvSpPr txBox="1"/>
          <p:nvPr/>
        </p:nvSpPr>
        <p:spPr>
          <a:xfrm>
            <a:off x="-171354" y="292392"/>
            <a:ext cx="1641953" cy="44642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>
              <a:lnSpc>
                <a:spcPts val="1700"/>
              </a:lnSpc>
              <a:spcAft>
                <a:spcPts val="800"/>
              </a:spcAft>
            </a:pPr>
            <a:r>
              <a:rPr lang="en-CA" sz="1200" kern="100" dirty="0">
                <a:effectLst/>
                <a:ea typeface="Calibri" panose="020F0502020204030204" pitchFamily="34" charset="0"/>
              </a:rPr>
              <a:t>Actinobacteria</a:t>
            </a:r>
          </a:p>
          <a:p>
            <a:pPr algn="r">
              <a:lnSpc>
                <a:spcPts val="17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Alphaproteobacteria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17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Gammaproteobacteria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17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Bacteroidia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17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Polyangia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17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Acidimicrobiia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17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Thermoleophilia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17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Vicinamibacteria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17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Verrucomicrobiae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17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Acidobacteriae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1700"/>
              </a:lnSpc>
              <a:spcAft>
                <a:spcPts val="800"/>
              </a:spcAft>
            </a:pPr>
            <a:r>
              <a:rPr lang="en-CA" sz="1200" kern="100" dirty="0" err="1">
                <a:effectLst/>
                <a:ea typeface="Calibri" panose="020F0502020204030204" pitchFamily="34" charset="0"/>
              </a:rPr>
              <a:t>Gemmatimonadetes</a:t>
            </a:r>
            <a:endParaRPr lang="en-CA" sz="1200" kern="100" dirty="0">
              <a:effectLst/>
              <a:ea typeface="Calibri" panose="020F0502020204030204" pitchFamily="34" charset="0"/>
            </a:endParaRPr>
          </a:p>
          <a:p>
            <a:pPr algn="r">
              <a:lnSpc>
                <a:spcPts val="1700"/>
              </a:lnSpc>
              <a:spcAft>
                <a:spcPts val="800"/>
              </a:spcAft>
            </a:pPr>
            <a:r>
              <a:rPr lang="en-CA" sz="1200" kern="100" dirty="0">
                <a:effectLst/>
                <a:ea typeface="Calibri" panose="020F0502020204030204" pitchFamily="34" charset="0"/>
              </a:rPr>
              <a:t>KD4-96</a:t>
            </a:r>
          </a:p>
          <a:p>
            <a:pPr algn="r">
              <a:lnSpc>
                <a:spcPts val="1700"/>
              </a:lnSpc>
              <a:spcAft>
                <a:spcPts val="800"/>
              </a:spcAft>
            </a:pPr>
            <a:r>
              <a:rPr lang="en-CA" sz="1200" kern="100" dirty="0">
                <a:effectLst/>
                <a:ea typeface="Calibri" panose="020F0502020204030204" pitchFamily="34" charset="0"/>
              </a:rPr>
              <a:t>MB-A2-108</a:t>
            </a:r>
          </a:p>
          <a:p>
            <a:pPr algn="r">
              <a:lnSpc>
                <a:spcPts val="1700"/>
              </a:lnSpc>
            </a:pPr>
            <a:endParaRPr lang="en-CA" sz="12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6FBBA3D-FD11-DA7D-25CB-ABE10A68F036}"/>
              </a:ext>
            </a:extLst>
          </p:cNvPr>
          <p:cNvSpPr txBox="1"/>
          <p:nvPr/>
        </p:nvSpPr>
        <p:spPr>
          <a:xfrm>
            <a:off x="-64748" y="1615399"/>
            <a:ext cx="400110" cy="120032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CA" sz="1400" dirty="0"/>
              <a:t>Taxa</a:t>
            </a:r>
          </a:p>
        </p:txBody>
      </p:sp>
    </p:spTree>
    <p:extLst>
      <p:ext uri="{BB962C8B-B14F-4D97-AF65-F5344CB8AC3E}">
        <p14:creationId xmlns:p14="http://schemas.microsoft.com/office/powerpoint/2010/main" val="31715386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474</Words>
  <Application>Microsoft Office PowerPoint</Application>
  <PresentationFormat>Widescreen</PresentationFormat>
  <Paragraphs>114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veedal@gmail.com</dc:creator>
  <cp:lastModifiedBy>niveedal@gmail.com</cp:lastModifiedBy>
  <cp:revision>3</cp:revision>
  <dcterms:created xsi:type="dcterms:W3CDTF">2023-04-25T12:11:14Z</dcterms:created>
  <dcterms:modified xsi:type="dcterms:W3CDTF">2023-04-25T12:45:35Z</dcterms:modified>
</cp:coreProperties>
</file>